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197"/>
  </p:normalViewPr>
  <p:slideViewPr>
    <p:cSldViewPr snapToGrid="0" snapToObjects="1">
      <p:cViewPr varScale="1">
        <p:scale>
          <a:sx n="119" d="100"/>
          <a:sy n="119" d="100"/>
        </p:scale>
        <p:origin x="2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3BF73F-E8C6-2C43-B6B9-A840E28539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D6742E-D517-DC46-B067-6E3267A197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7CCD5E-1AFD-E046-9BFA-457E99229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512DA4-1AA8-CB4E-B0DC-BAABC388C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A64943-C65A-F740-AD48-626BB3FB82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545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C8590-9E28-0948-A854-A6F0A9577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F46D98-EF2B-E84E-AFBA-2D24ECD009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348CFC-B770-3F44-B570-D924A0DFD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7025F-88F3-2646-90B0-EA61590B4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4C3C5D-EFDB-7940-854E-473177329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029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82567A-2DA5-8345-98AD-6303009AC1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D56A41-F633-6C4F-9CCF-061D1BB611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7C4C7A-EBFA-4E4C-ACE6-28EC2BA7B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DB27E-A745-FE44-AE75-897463102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EE924-76CB-6049-A3EA-014998BF3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022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44085-EE60-D34A-B23D-05CAAF6A43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B00C48-6B05-3947-9C93-B9322CF1715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847223-11E3-8C40-8414-007B2A76C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9A33BE-6516-EC4B-914D-F55AED7C0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D1DB21-CBAC-3F47-ABE8-118F026E0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15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629634-5871-5549-8342-8321DF472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5BB276-A1B5-C74A-837F-494529E71A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66D76A-3EE8-6740-A456-28D899C38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D1B156-9233-0C43-8F78-A5E292C22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1E281-ED68-0E46-B979-C9214164E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356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0ACFF-4F96-124C-8A05-1E3D62109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AE0EAA-01AA-994D-9438-AC55BDA530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CF2B88-4F95-4944-A121-C80364C2E3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5A56DD-26C1-5649-977F-2E1B0E46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1D8A35-8704-4942-8BD7-C07FE1132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E1501B-E45E-0C4B-9428-FB928BBED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423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7F3C3-3347-E94E-8B44-A2FC9C9521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550DCC-870C-1D43-8C5F-0CE10A522B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DE8D4F-4C23-D64A-8487-DEC4084ECE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55347A-693E-2A47-971A-D79A1296A5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42842D-4251-9747-B224-596FCFDFDA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EFD4BE-FD55-BD4D-956E-B73C569CF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916AB3-6DBD-0A43-BA27-20ABE5CC1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A5A618-F94D-5641-ACB2-7CA63C576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835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8F5074-D99A-204A-A59C-2A34CFEB85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43D126-A590-1B4F-BCD7-B92D0500E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0036E5-7C14-7946-A726-1572E9952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B70ECC-BBEA-414F-87DE-58CDBAB42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965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C5BADBA-310B-954C-9AB1-BAB1A0AE0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17F783-A742-7543-93C1-84EB314C6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8A4A90-0E69-AF4F-90EC-032D3AA85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370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6309F3-476F-7748-909B-1D0B1F0D6F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1FCA3F-A12A-F24A-924C-5C1B9D2829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BC4D58-115D-EE47-817A-409B52B2C4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0433D9-E001-2B4D-A332-C9FA19606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4FA080-E775-BD4F-9BF7-F6E0DB916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B812F6-D342-7E40-BEAD-496F10A4D5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302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B47E80-61A2-C54C-892E-4555770FA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BC5B45-1704-B143-9BEF-84F6FCC253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311599-63E9-AE4F-A9D3-CD369298EC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0EB17D-949C-F44A-B479-DD9EB8778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EE7DBD-5DB9-1F42-B454-5A0CCAED9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5BB5CC-31C5-F84A-B7AA-8343D8FD8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271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82D420-4B35-8E4A-B73B-D8E4F87D7C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581D0C-D1EB-BF4D-945D-DAD0C420AE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A4F5F0-3112-BA44-8D36-BB3AA2E611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E30CD-0078-D643-9355-409FBE409B71}" type="datetimeFigureOut">
              <a:rPr lang="en-US" smtClean="0"/>
              <a:t>11/1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04E598-E4A6-EF40-A319-7807B485C7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E81B39-5276-B949-9614-58FAAE3D40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CC7EF-9621-6E47-81AC-87589593D9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827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2C03A19A-2238-4C46-AD61-771EFFE8EDA5}"/>
              </a:ext>
            </a:extLst>
          </p:cNvPr>
          <p:cNvSpPr/>
          <p:nvPr/>
        </p:nvSpPr>
        <p:spPr>
          <a:xfrm>
            <a:off x="3581400" y="1320730"/>
            <a:ext cx="5029200" cy="42165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M   E   K   D   D   N   S   D   K   V   C   L   S   V   K   E   K   Y   T   S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g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ac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   Q   P   E   E   M   V   T   N   L   K   A   S   V   R   E   L   S   V   K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V   K   E   Q   R   K   C   D   A   K   D   K   L   Q   Q   L   R   E   R   I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S   K   E   V   V   D   V   S   V   Q   E   L   I   P   L   L   R   S   L   K 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   F   V   K   E   E   S   E   V   R   S   R   C   N   V   K   R   S   A   L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gag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   D   A   V   H   D   L   E   E   R   A   G   K   G   L   D   G   E   I   Q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   E   D   L   D   G   L   L   V   V   S   L   D   N   L   T   S   A   K   K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   L   G   A   T   L   R   E   I   V   S   L   K   R   Q   I   D   D   V   P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   Q   S   E   L   L   Q   Y   E   R   R   F   S   E   L   N   V   C   I   Q 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a tac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   K   L   Q   Q   T   R   K   L   Y   A   T   Y   N   A   L   L   E   I   K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ac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D   L   M   L   K   E   T   S   L   L   N   S   I   G   S   Q   F   Q   D   V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t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I   G   T   P   A   G   R   V   K   L   I   D   S   M   E   G   V   M   K   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c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t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I   Q   Q   K   I   G   K   I   Q   L   G   L   Q   E   E   Q   R   L   R   D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c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   S   K   E   K   Y   I   A   A   A   A   E   Q   R   K   C   Y   T   V   L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tac cag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c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gag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aga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cat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ct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g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R   A   Y   Q   E   E   C   T   K   N   E   R   L   R   S   H   I   S   A   M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ga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tc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dirty="0" err="1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tga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sz="800" b="1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N   E   H   L   -</a:t>
            </a:r>
            <a:r>
              <a:rPr lang="en-US" sz="800" dirty="0">
                <a:latin typeface="Courier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Courier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5446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Lewis</dc:creator>
  <cp:lastModifiedBy>Connor Lewis</cp:lastModifiedBy>
  <cp:revision>1</cp:revision>
  <dcterms:created xsi:type="dcterms:W3CDTF">2022-09-13T16:46:46Z</dcterms:created>
  <dcterms:modified xsi:type="dcterms:W3CDTF">2022-11-18T19:09:45Z</dcterms:modified>
</cp:coreProperties>
</file>